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37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2517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9045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6979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0108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3666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97617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1139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826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9808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3794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962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888616-54F0-47E7-9D7B-0ADF4B0655FA}" type="datetimeFigureOut">
              <a:rPr lang="es-ES" smtClean="0"/>
              <a:t>27/12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03A3BC-1957-453C-98F0-6DB88567509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7172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075756" y="367759"/>
            <a:ext cx="10047412" cy="6143302"/>
            <a:chOff x="1075756" y="367759"/>
            <a:chExt cx="10047412" cy="6143302"/>
          </a:xfrm>
        </p:grpSpPr>
        <p:sp>
          <p:nvSpPr>
            <p:cNvPr id="4" name="TextBox 3"/>
            <p:cNvSpPr txBox="1"/>
            <p:nvPr/>
          </p:nvSpPr>
          <p:spPr>
            <a:xfrm>
              <a:off x="1075756" y="367759"/>
              <a:ext cx="3768532" cy="923330"/>
            </a:xfrm>
            <a:prstGeom prst="rect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s-ES" b="1" dirty="0" err="1" smtClean="0"/>
                <a:t>PubMed</a:t>
              </a:r>
              <a:r>
                <a:rPr lang="es-ES" b="1" dirty="0" smtClean="0"/>
                <a:t> </a:t>
              </a:r>
              <a:r>
                <a:rPr lang="es-ES" b="1" dirty="0" err="1" smtClean="0"/>
                <a:t>search</a:t>
              </a:r>
              <a:endParaRPr lang="es-ES" b="1" dirty="0" smtClean="0"/>
            </a:p>
            <a:p>
              <a:r>
                <a:rPr lang="es-ES" dirty="0" err="1" smtClean="0"/>
                <a:t>Terms</a:t>
              </a:r>
              <a:r>
                <a:rPr lang="es-ES" dirty="0" smtClean="0"/>
                <a:t>: pre-eclampsia AND </a:t>
              </a:r>
              <a:r>
                <a:rPr lang="es-ES" dirty="0" err="1" smtClean="0"/>
                <a:t>proteomics</a:t>
              </a:r>
              <a:endParaRPr lang="es-ES" dirty="0" smtClean="0"/>
            </a:p>
            <a:p>
              <a:r>
                <a:rPr lang="es-ES" dirty="0" smtClean="0"/>
                <a:t>Field: </a:t>
              </a:r>
              <a:r>
                <a:rPr lang="es-ES" dirty="0" err="1" smtClean="0"/>
                <a:t>Title</a:t>
              </a:r>
              <a:r>
                <a:rPr lang="es-ES" dirty="0" smtClean="0"/>
                <a:t>/</a:t>
              </a:r>
              <a:r>
                <a:rPr lang="es-ES" dirty="0" err="1" smtClean="0"/>
                <a:t>Abstract</a:t>
              </a:r>
              <a:endParaRPr lang="es-ES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354636" y="367759"/>
              <a:ext cx="3768532" cy="923330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s-ES" b="1" dirty="0" err="1" smtClean="0"/>
                <a:t>PubMed</a:t>
              </a:r>
              <a:r>
                <a:rPr lang="es-ES" b="1" dirty="0" smtClean="0"/>
                <a:t> </a:t>
              </a:r>
              <a:r>
                <a:rPr lang="es-ES" b="1" dirty="0" err="1" smtClean="0"/>
                <a:t>search</a:t>
              </a:r>
              <a:endParaRPr lang="es-ES" b="1" dirty="0" smtClean="0"/>
            </a:p>
            <a:p>
              <a:r>
                <a:rPr lang="es-ES" dirty="0" err="1" smtClean="0"/>
                <a:t>Terms</a:t>
              </a:r>
              <a:r>
                <a:rPr lang="es-ES" dirty="0" smtClean="0"/>
                <a:t>: pre-eclampsia AND </a:t>
              </a:r>
              <a:r>
                <a:rPr lang="es-ES" dirty="0" err="1" smtClean="0"/>
                <a:t>proteomics</a:t>
              </a:r>
              <a:endParaRPr lang="es-ES" dirty="0" smtClean="0"/>
            </a:p>
            <a:p>
              <a:r>
                <a:rPr lang="es-ES" dirty="0" smtClean="0"/>
                <a:t>Field: </a:t>
              </a:r>
              <a:r>
                <a:rPr lang="es-ES" dirty="0" err="1" smtClean="0"/>
                <a:t>MeSH</a:t>
              </a:r>
              <a:r>
                <a:rPr lang="es-ES" dirty="0" smtClean="0"/>
                <a:t> </a:t>
              </a:r>
              <a:r>
                <a:rPr lang="es-ES" dirty="0" err="1" smtClean="0"/>
                <a:t>terms</a:t>
              </a:r>
              <a:endParaRPr lang="es-ES" dirty="0"/>
            </a:p>
          </p:txBody>
        </p:sp>
        <p:sp>
          <p:nvSpPr>
            <p:cNvPr id="6" name="Down Arrow 5"/>
            <p:cNvSpPr/>
            <p:nvPr/>
          </p:nvSpPr>
          <p:spPr>
            <a:xfrm>
              <a:off x="2764673" y="1287391"/>
              <a:ext cx="390698" cy="540327"/>
            </a:xfrm>
            <a:prstGeom prst="downArrow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" name="Down Arrow 6"/>
            <p:cNvSpPr/>
            <p:nvPr/>
          </p:nvSpPr>
          <p:spPr>
            <a:xfrm>
              <a:off x="9043553" y="1287391"/>
              <a:ext cx="390698" cy="540327"/>
            </a:xfrm>
            <a:prstGeom prst="downArrow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932144" y="1827718"/>
              <a:ext cx="2055756" cy="369332"/>
            </a:xfrm>
            <a:prstGeom prst="rect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s-ES" dirty="0" smtClean="0"/>
                <a:t>60 </a:t>
              </a:r>
              <a:r>
                <a:rPr lang="es-ES" dirty="0" err="1" smtClean="0"/>
                <a:t>articles</a:t>
              </a:r>
              <a:r>
                <a:rPr lang="es-ES" dirty="0" smtClean="0"/>
                <a:t> </a:t>
              </a:r>
              <a:r>
                <a:rPr lang="es-ES" dirty="0" err="1" smtClean="0"/>
                <a:t>retrieved</a:t>
              </a:r>
              <a:endParaRPr lang="es-E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211024" y="1827718"/>
              <a:ext cx="2055756" cy="36933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s-ES" dirty="0" smtClean="0"/>
                <a:t>90 </a:t>
              </a:r>
              <a:r>
                <a:rPr lang="es-ES" dirty="0" err="1" smtClean="0"/>
                <a:t>articles</a:t>
              </a:r>
              <a:r>
                <a:rPr lang="es-ES" dirty="0" smtClean="0"/>
                <a:t> </a:t>
              </a:r>
              <a:r>
                <a:rPr lang="es-ES" dirty="0" err="1" smtClean="0"/>
                <a:t>retrieved</a:t>
              </a:r>
              <a:endParaRPr lang="es-ES" dirty="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380830" y="1827718"/>
              <a:ext cx="3412423" cy="369332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dirty="0" smtClean="0">
                  <a:solidFill>
                    <a:schemeClr val="tx1"/>
                  </a:solidFill>
                </a:rPr>
                <a:t>COMBINE</a:t>
              </a:r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3" name="Down Arrow 12"/>
            <p:cNvSpPr/>
            <p:nvPr/>
          </p:nvSpPr>
          <p:spPr>
            <a:xfrm>
              <a:off x="5916534" y="2197049"/>
              <a:ext cx="360000" cy="2268000"/>
            </a:xfrm>
            <a:prstGeom prst="downArrow">
              <a:avLst/>
            </a:prstGeom>
            <a:solidFill>
              <a:schemeClr val="accent1">
                <a:lumMod val="60000"/>
                <a:lumOff val="40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517700" y="4490055"/>
              <a:ext cx="1148071" cy="369332"/>
            </a:xfrm>
            <a:prstGeom prst="rect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s-ES" dirty="0" smtClean="0"/>
                <a:t>69 </a:t>
              </a:r>
              <a:r>
                <a:rPr lang="es-ES" dirty="0" err="1" smtClean="0"/>
                <a:t>articles</a:t>
              </a:r>
              <a:endParaRPr lang="es-ES" dirty="0"/>
            </a:p>
          </p:txBody>
        </p:sp>
        <p:sp>
          <p:nvSpPr>
            <p:cNvPr id="16" name="Bent-Up Arrow 15"/>
            <p:cNvSpPr/>
            <p:nvPr/>
          </p:nvSpPr>
          <p:spPr>
            <a:xfrm rot="5400000">
              <a:off x="5804860" y="2412929"/>
              <a:ext cx="1147741" cy="732608"/>
            </a:xfrm>
            <a:prstGeom prst="bentUpArrow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924056" y="2559238"/>
              <a:ext cx="2329484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 err="1" smtClean="0"/>
                <a:t>Remove</a:t>
              </a:r>
              <a:r>
                <a:rPr lang="es-ES" dirty="0" smtClean="0"/>
                <a:t>: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s-ES" dirty="0" err="1" smtClean="0"/>
                <a:t>Duplicates</a:t>
              </a:r>
              <a:endParaRPr lang="es-ES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s-ES" dirty="0" err="1" smtClean="0"/>
                <a:t>Reviews</a:t>
              </a:r>
              <a:endParaRPr lang="es-ES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s-ES" dirty="0" smtClean="0"/>
                <a:t>Non-</a:t>
              </a:r>
              <a:r>
                <a:rPr lang="es-ES" dirty="0" err="1" smtClean="0"/>
                <a:t>english</a:t>
              </a:r>
              <a:r>
                <a:rPr lang="es-ES" dirty="0" smtClean="0"/>
                <a:t> </a:t>
              </a:r>
              <a:r>
                <a:rPr lang="es-ES" dirty="0" err="1" smtClean="0"/>
                <a:t>articles</a:t>
              </a:r>
              <a:endParaRPr lang="es-ES" dirty="0" smtClean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160034" y="3756269"/>
              <a:ext cx="187352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dirty="0" smtClean="0"/>
                <a:t>Manual </a:t>
              </a:r>
              <a:r>
                <a:rPr lang="es-ES" dirty="0" err="1" smtClean="0"/>
                <a:t>validation</a:t>
              </a:r>
              <a:endParaRPr lang="es-ES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2499730" y="5273923"/>
              <a:ext cx="7200000" cy="180000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0" name="Down Arrow 19"/>
            <p:cNvSpPr/>
            <p:nvPr/>
          </p:nvSpPr>
          <p:spPr>
            <a:xfrm>
              <a:off x="5916534" y="4864058"/>
              <a:ext cx="360000" cy="396000"/>
            </a:xfrm>
            <a:prstGeom prst="downArrow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1" name="Down Arrow 20"/>
            <p:cNvSpPr/>
            <p:nvPr/>
          </p:nvSpPr>
          <p:spPr>
            <a:xfrm>
              <a:off x="4745095" y="5449685"/>
              <a:ext cx="360000" cy="396000"/>
            </a:xfrm>
            <a:prstGeom prst="downArrow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2" name="Down Arrow 21"/>
            <p:cNvSpPr/>
            <p:nvPr/>
          </p:nvSpPr>
          <p:spPr>
            <a:xfrm>
              <a:off x="7085517" y="5449685"/>
              <a:ext cx="360000" cy="396000"/>
            </a:xfrm>
            <a:prstGeom prst="downArrow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3" name="Down Arrow 22"/>
            <p:cNvSpPr/>
            <p:nvPr/>
          </p:nvSpPr>
          <p:spPr>
            <a:xfrm>
              <a:off x="2407939" y="5449685"/>
              <a:ext cx="360000" cy="396000"/>
            </a:xfrm>
            <a:prstGeom prst="downArrow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4" name="Down Arrow 23"/>
            <p:cNvSpPr/>
            <p:nvPr/>
          </p:nvSpPr>
          <p:spPr>
            <a:xfrm>
              <a:off x="9429204" y="5449685"/>
              <a:ext cx="360000" cy="396000"/>
            </a:xfrm>
            <a:prstGeom prst="downArrow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013903" y="5864730"/>
              <a:ext cx="1148071" cy="646331"/>
            </a:xfrm>
            <a:prstGeom prst="rect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s-ES" dirty="0" smtClean="0"/>
                <a:t>Placenta</a:t>
              </a:r>
            </a:p>
            <a:p>
              <a:r>
                <a:rPr lang="es-ES" dirty="0" smtClean="0"/>
                <a:t>23 </a:t>
              </a:r>
              <a:r>
                <a:rPr lang="es-ES" dirty="0" err="1" smtClean="0"/>
                <a:t>articles</a:t>
              </a:r>
              <a:endParaRPr lang="es-ES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195343" y="5864730"/>
              <a:ext cx="1552028" cy="646331"/>
            </a:xfrm>
            <a:prstGeom prst="rect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s-ES" dirty="0" err="1" smtClean="0"/>
                <a:t>Serum</a:t>
              </a:r>
              <a:r>
                <a:rPr lang="es-ES" dirty="0" smtClean="0"/>
                <a:t>/plasma</a:t>
              </a:r>
            </a:p>
            <a:p>
              <a:r>
                <a:rPr lang="es-ES" dirty="0" smtClean="0"/>
                <a:t>32 </a:t>
              </a:r>
              <a:r>
                <a:rPr lang="es-ES" dirty="0" err="1" smtClean="0"/>
                <a:t>articles</a:t>
              </a:r>
              <a:endParaRPr lang="es-ES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599151" y="5864730"/>
              <a:ext cx="2020105" cy="646331"/>
            </a:xfrm>
            <a:prstGeom prst="rect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s-ES" dirty="0" err="1" smtClean="0"/>
                <a:t>Other</a:t>
              </a:r>
              <a:r>
                <a:rPr lang="es-ES" dirty="0" smtClean="0"/>
                <a:t> </a:t>
              </a:r>
              <a:r>
                <a:rPr lang="es-ES" dirty="0" err="1" smtClean="0"/>
                <a:t>tissues</a:t>
              </a:r>
              <a:r>
                <a:rPr lang="es-ES" dirty="0" smtClean="0"/>
                <a:t>/</a:t>
              </a:r>
              <a:r>
                <a:rPr lang="es-ES" dirty="0" err="1" smtClean="0"/>
                <a:t>fluids</a:t>
              </a:r>
              <a:endParaRPr lang="es-ES" dirty="0" smtClean="0"/>
            </a:p>
            <a:p>
              <a:r>
                <a:rPr lang="es-ES" dirty="0" smtClean="0"/>
                <a:t>5 </a:t>
              </a:r>
              <a:r>
                <a:rPr lang="es-ES" dirty="0" err="1" smtClean="0"/>
                <a:t>articles</a:t>
              </a:r>
              <a:endParaRPr lang="es-ES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780741" y="5864730"/>
              <a:ext cx="1031051" cy="646331"/>
            </a:xfrm>
            <a:prstGeom prst="rect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s-ES" dirty="0" err="1" smtClean="0"/>
                <a:t>Urine</a:t>
              </a:r>
              <a:endParaRPr lang="es-ES" dirty="0" smtClean="0"/>
            </a:p>
            <a:p>
              <a:r>
                <a:rPr lang="es-ES" dirty="0" smtClean="0"/>
                <a:t>9 </a:t>
              </a:r>
              <a:r>
                <a:rPr lang="es-ES" dirty="0" err="1" smtClean="0"/>
                <a:t>articles</a:t>
              </a:r>
              <a:endParaRPr lang="es-ES" dirty="0"/>
            </a:p>
          </p:txBody>
        </p:sp>
      </p:grpSp>
    </p:spTree>
    <p:extLst>
      <p:ext uri="{BB962C8B-B14F-4D97-AF65-F5344CB8AC3E}">
        <p14:creationId xmlns:p14="http://schemas.microsoft.com/office/powerpoint/2010/main" val="2277183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51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berto paradela</dc:creator>
  <cp:lastModifiedBy>alberto paradela</cp:lastModifiedBy>
  <cp:revision>14</cp:revision>
  <dcterms:created xsi:type="dcterms:W3CDTF">2020-12-21T08:34:51Z</dcterms:created>
  <dcterms:modified xsi:type="dcterms:W3CDTF">2020-12-27T17:19:24Z</dcterms:modified>
</cp:coreProperties>
</file>